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6" d="100"/>
          <a:sy n="86" d="100"/>
        </p:scale>
        <p:origin x="65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88636D-9A32-4A66-9B89-7B2488B07B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734806A-FA5B-4FDB-9F2E-560732C5CA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198AF4-01CA-4B4D-808D-656714F969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DE1A-0007-4F60-BD07-A6FDAA59D63D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B05149B-EBF4-4CA2-B215-E5B5D43E9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39DE53-3B00-45DD-9C0C-E7AD61AF6E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5FD65-16B3-4EE0-A35D-E70EBCCFAA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0796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FE38D7-F65C-4689-8CF6-D97160313C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9F95A3B-6A01-46EE-97DA-7FF79CDBF8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A0119DA-032D-4BE8-8D89-8F34A1908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DE1A-0007-4F60-BD07-A6FDAA59D63D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8DEB98D-CCA3-4F1D-9562-9441530CC5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143AC1-C841-4190-A59C-2B4A9F173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5FD65-16B3-4EE0-A35D-E70EBCCFAA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2857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EE6CA8F-BCDC-4655-9F21-F4433B70FB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D4FF3AA-6693-4345-9DD8-14E80E60DF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43C1831-951A-486B-9848-A870AE9DD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DE1A-0007-4F60-BD07-A6FDAA59D63D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5622C8-024D-4E51-B2DC-6BAC169D40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55A9ED3-A34C-4E1A-9DDD-BB89ED248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5FD65-16B3-4EE0-A35D-E70EBCCFAA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1248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BF9BB0-8721-4B99-A94A-19514378FE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FE4D33F-163A-4C4B-9EDD-775389BE07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2FD4DB-D882-4FB6-B521-644787EAE2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DE1A-0007-4F60-BD07-A6FDAA59D63D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BF98F6-B393-40E0-90E0-3CFB0E986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E1BEB9-A01E-4F89-9BF0-25892DDD6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5FD65-16B3-4EE0-A35D-E70EBCCFAA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79603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4C051C-6B28-4F2A-A831-7398146D2C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4DB9C5A-BAEF-43E9-A30E-3C26D81EB6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967B914-50DC-42B2-911A-5940D28480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DE1A-0007-4F60-BD07-A6FDAA59D63D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AEFC2C-B2DE-4264-9748-52F490F72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6C6812-4866-44BC-A7CE-51A78F8460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5FD65-16B3-4EE0-A35D-E70EBCCFAA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99116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7B7EBD-11E2-4F65-9B35-885BFEF84F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B4D999D-BA1F-456C-87B0-6B295CA2A6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A415517-186F-4A26-A9C2-BA63141B6B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F564733-2AE1-4971-A754-E4FDF754B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DE1A-0007-4F60-BD07-A6FDAA59D63D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ACE9815-B272-40F5-AB59-41D2A9B96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ECF2F7A-AD3C-4C68-BEDC-5EE2229064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5FD65-16B3-4EE0-A35D-E70EBCCFAA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9081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F576AC-235A-4602-A3CF-4B185484BA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5336F82-EAED-4A17-BD1C-7EC141DE6F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33D32D5-1C75-4858-93E2-9167C9D296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798DDB1-C605-49AC-9ED7-1D69539E9D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94EB239-8106-400F-8F74-CE1668BAF5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AD0DBFB-DF54-4E0D-9607-429BE1C94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DE1A-0007-4F60-BD07-A6FDAA59D63D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2BF36F3-D732-465C-BB15-C5105BABA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D3B3DBD-E77B-43D4-BD3E-91D2EC652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5FD65-16B3-4EE0-A35D-E70EBCCFAA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6237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16F83C-9FF2-4A56-A3A6-E24DE111CA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B180F85-7642-463F-BF8B-D2A7AF74D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DE1A-0007-4F60-BD07-A6FDAA59D63D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00865D3-3D45-446F-83C2-D55626DE6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D6B110F-C57A-44DA-A998-478ABE4B6C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5FD65-16B3-4EE0-A35D-E70EBCCFAA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4608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E4DAF0E-3E88-4DED-9649-FAD3F0611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DE1A-0007-4F60-BD07-A6FDAA59D63D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7891581-550D-4B80-94DD-2546D094C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3369D5A-361D-44DD-B42A-1478716B5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5FD65-16B3-4EE0-A35D-E70EBCCFAA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9920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A8C95B-2E48-4CCA-910C-37B499C471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12D9B1A-2DB7-4427-8FB7-3F6E48AE50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69580ED-F468-4325-935E-212F928003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2F3CBAB-B8E2-4BFC-9773-55F04C572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DE1A-0007-4F60-BD07-A6FDAA59D63D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E4724B8-85E5-4BCF-BA0A-42ABC60A8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CD7EBCA-0C90-4AB0-BA18-C9EC0E3B6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5FD65-16B3-4EE0-A35D-E70EBCCFAA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7934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79706F-769F-4AC7-A636-CD79AFEB3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A4D8BCE-4F7E-441B-877C-5D3D310FD6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168A672-0062-4193-B75C-AA1AF27D60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75CE4EF-1D5B-41DB-9687-9C37C4299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DE1A-0007-4F60-BD07-A6FDAA59D63D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52C2EB6-2578-469C-ABF4-5314E21A1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216ABBC-E6C0-4A5C-928D-8423D47F92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5FD65-16B3-4EE0-A35D-E70EBCCFAA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6968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2A3B149-9D0B-4739-9A11-209D6836C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4B14DEB-3D18-4EC1-B9DF-45F5375B40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FAE1FD-EC25-44D6-A385-31109F3D27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FDE1A-0007-4F60-BD07-A6FDAA59D63D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F418CFE-873B-4007-8524-25BC2C9E90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0252FF-37CE-4B1D-9DEF-417DA618E5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5FD65-16B3-4EE0-A35D-E70EBCCFAA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1193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4">
            <a:extLst>
              <a:ext uri="{FF2B5EF4-FFF2-40B4-BE49-F238E27FC236}">
                <a16:creationId xmlns:a16="http://schemas.microsoft.com/office/drawing/2014/main" id="{DBEC297B-CEAA-4AE0-89D0-1CF6BCC96FEE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666875" y="2798763"/>
            <a:ext cx="6127750" cy="1635125"/>
            <a:chOff x="1050" y="1763"/>
            <a:chExt cx="3860" cy="1030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2CC1730E-9001-49BA-97A6-06FC735F8752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050" y="1763"/>
              <a:ext cx="3860" cy="10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Oval 5">
              <a:extLst>
                <a:ext uri="{FF2B5EF4-FFF2-40B4-BE49-F238E27FC236}">
                  <a16:creationId xmlns:a16="http://schemas.microsoft.com/office/drawing/2014/main" id="{87A344BD-1045-4116-BF39-2CAB0010E9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7" y="2224"/>
              <a:ext cx="471" cy="313"/>
            </a:xfrm>
            <a:prstGeom prst="ellipse">
              <a:avLst/>
            </a:prstGeom>
            <a:solidFill>
              <a:srgbClr val="92CDDC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Oval 6">
              <a:extLst>
                <a:ext uri="{FF2B5EF4-FFF2-40B4-BE49-F238E27FC236}">
                  <a16:creationId xmlns:a16="http://schemas.microsoft.com/office/drawing/2014/main" id="{232A7E89-865B-447B-BC91-9C4C9A2721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7" y="2224"/>
              <a:ext cx="471" cy="313"/>
            </a:xfrm>
            <a:prstGeom prst="ellipse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42E5879A-9FC4-4A04-89B2-67F4CFDB79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4" y="2337"/>
              <a:ext cx="324" cy="1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Raw imag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34AD20BD-C561-4D97-9E61-5A2C607231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6" y="1861"/>
              <a:ext cx="628" cy="224"/>
            </a:xfrm>
            <a:prstGeom prst="rect">
              <a:avLst/>
            </a:prstGeom>
            <a:solidFill>
              <a:srgbClr val="D9958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441D7232-0818-470A-B532-DECD6A4CB8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6" y="1861"/>
              <a:ext cx="628" cy="224"/>
            </a:xfrm>
            <a:prstGeom prst="rect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87F6B74E-3921-4B7A-9199-B57C829CAA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0" y="1930"/>
              <a:ext cx="503" cy="1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Part affinity field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959CCFB6-CD93-4012-AA5B-5116ECB3F1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6" y="2566"/>
              <a:ext cx="628" cy="223"/>
            </a:xfrm>
            <a:prstGeom prst="rect">
              <a:avLst/>
            </a:prstGeom>
            <a:solidFill>
              <a:srgbClr val="D9958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29C7B4DC-FE24-4A84-A4DC-DDC6D992EE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6" y="2566"/>
              <a:ext cx="628" cy="223"/>
            </a:xfrm>
            <a:prstGeom prst="rect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BD8B6F82-BCB3-40B9-A3D7-D1A8E842CD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6" y="2634"/>
              <a:ext cx="590" cy="1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Part confidence map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7B180CEA-7A3D-44C4-AD65-6FB480E958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9" y="1771"/>
              <a:ext cx="628" cy="314"/>
            </a:xfrm>
            <a:prstGeom prst="rect">
              <a:avLst/>
            </a:prstGeom>
            <a:solidFill>
              <a:srgbClr val="DDD6E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360CD0BF-013F-485B-A6C8-190400892E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9" y="1771"/>
              <a:ext cx="628" cy="314"/>
            </a:xfrm>
            <a:prstGeom prst="rect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8F6104BC-4F53-4845-8023-381FA2597B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9" y="1839"/>
              <a:ext cx="253" cy="1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Bipartit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AD8F4CA0-50BD-442B-BFBC-5DC8F8D8AD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1" y="1932"/>
              <a:ext cx="249" cy="1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aching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3CAC1001-4530-40E2-940B-A328DE8B3D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9" y="2566"/>
              <a:ext cx="628" cy="223"/>
            </a:xfrm>
            <a:prstGeom prst="rect">
              <a:avLst/>
            </a:prstGeom>
            <a:solidFill>
              <a:srgbClr val="FBD7B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120AEFF2-D080-4CBB-8858-EB2AA1EE08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9" y="2566"/>
              <a:ext cx="628" cy="223"/>
            </a:xfrm>
            <a:prstGeom prst="rect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E1A3018C-E565-4E1C-B525-B0688CFB51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0" y="2634"/>
              <a:ext cx="412" cy="1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Parsing result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77E70A25-3E4A-4291-8749-B30C8E054D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2" y="1816"/>
              <a:ext cx="628" cy="224"/>
            </a:xfrm>
            <a:prstGeom prst="rect">
              <a:avLst/>
            </a:prstGeom>
            <a:solidFill>
              <a:srgbClr val="FEE59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9FA9F33C-B56B-4CA5-8EAC-FC78BC8AF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2" y="1816"/>
              <a:ext cx="628" cy="224"/>
            </a:xfrm>
            <a:prstGeom prst="rect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562D35CF-1F23-4F8B-92FE-0486B50EA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8" y="1885"/>
              <a:ext cx="303" cy="1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Normaliz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FBE14A08-084E-4AC0-ACD4-61B8A6063A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2" y="2566"/>
              <a:ext cx="628" cy="223"/>
            </a:xfrm>
            <a:prstGeom prst="rect">
              <a:avLst/>
            </a:prstGeom>
            <a:solidFill>
              <a:srgbClr val="D7E3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8ED0C8DB-3479-4436-AAA9-E72C293279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2" y="2566"/>
              <a:ext cx="628" cy="223"/>
            </a:xfrm>
            <a:prstGeom prst="rect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A2711D6A-E3CE-4396-8A9A-16F33B6E00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6" y="2634"/>
              <a:ext cx="166" cy="1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Filter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Oval 27">
              <a:extLst>
                <a:ext uri="{FF2B5EF4-FFF2-40B4-BE49-F238E27FC236}">
                  <a16:creationId xmlns:a16="http://schemas.microsoft.com/office/drawing/2014/main" id="{9A39E347-A3A7-45CA-922A-FF9B2CC809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8" y="2160"/>
              <a:ext cx="477" cy="313"/>
            </a:xfrm>
            <a:prstGeom prst="ellipse">
              <a:avLst/>
            </a:prstGeom>
            <a:solidFill>
              <a:srgbClr val="92CDDC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" name="Oval 28">
              <a:extLst>
                <a:ext uri="{FF2B5EF4-FFF2-40B4-BE49-F238E27FC236}">
                  <a16:creationId xmlns:a16="http://schemas.microsoft.com/office/drawing/2014/main" id="{78EC0DB1-218A-48C2-BFE6-E3E09569B1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8" y="2160"/>
              <a:ext cx="477" cy="313"/>
            </a:xfrm>
            <a:prstGeom prst="ellipse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581C3272-C135-4326-89F8-A3F5E4B2DE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2" y="2273"/>
              <a:ext cx="374" cy="1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Pose feature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Freeform 30">
              <a:extLst>
                <a:ext uri="{FF2B5EF4-FFF2-40B4-BE49-F238E27FC236}">
                  <a16:creationId xmlns:a16="http://schemas.microsoft.com/office/drawing/2014/main" id="{71F8AA66-5989-4746-AB8D-E7AF74AFA8DB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8" y="1973"/>
              <a:ext cx="86" cy="408"/>
            </a:xfrm>
            <a:custGeom>
              <a:avLst/>
              <a:gdLst>
                <a:gd name="T0" fmla="*/ 0 w 86"/>
                <a:gd name="T1" fmla="*/ 408 h 408"/>
                <a:gd name="T2" fmla="*/ 59 w 86"/>
                <a:gd name="T3" fmla="*/ 408 h 408"/>
                <a:gd name="T4" fmla="*/ 59 w 86"/>
                <a:gd name="T5" fmla="*/ 0 h 408"/>
                <a:gd name="T6" fmla="*/ 86 w 86"/>
                <a:gd name="T7" fmla="*/ 0 h 4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86" h="408">
                  <a:moveTo>
                    <a:pt x="0" y="408"/>
                  </a:moveTo>
                  <a:lnTo>
                    <a:pt x="59" y="408"/>
                  </a:lnTo>
                  <a:lnTo>
                    <a:pt x="59" y="0"/>
                  </a:lnTo>
                  <a:lnTo>
                    <a:pt x="86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" name="Freeform 31">
              <a:extLst>
                <a:ext uri="{FF2B5EF4-FFF2-40B4-BE49-F238E27FC236}">
                  <a16:creationId xmlns:a16="http://schemas.microsoft.com/office/drawing/2014/main" id="{8490FF15-A3A5-4E8A-83C5-61E351CF5763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0" y="1952"/>
              <a:ext cx="36" cy="42"/>
            </a:xfrm>
            <a:custGeom>
              <a:avLst/>
              <a:gdLst>
                <a:gd name="T0" fmla="*/ 0 w 36"/>
                <a:gd name="T1" fmla="*/ 0 h 42"/>
                <a:gd name="T2" fmla="*/ 36 w 36"/>
                <a:gd name="T3" fmla="*/ 21 h 42"/>
                <a:gd name="T4" fmla="*/ 0 w 36"/>
                <a:gd name="T5" fmla="*/ 42 h 42"/>
                <a:gd name="T6" fmla="*/ 0 w 36"/>
                <a:gd name="T7" fmla="*/ 0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42">
                  <a:moveTo>
                    <a:pt x="0" y="0"/>
                  </a:moveTo>
                  <a:lnTo>
                    <a:pt x="36" y="21"/>
                  </a:lnTo>
                  <a:lnTo>
                    <a:pt x="0" y="4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" name="Freeform 32">
              <a:extLst>
                <a:ext uri="{FF2B5EF4-FFF2-40B4-BE49-F238E27FC236}">
                  <a16:creationId xmlns:a16="http://schemas.microsoft.com/office/drawing/2014/main" id="{1887A7C2-82F1-4CD4-AA47-9E219AB8B499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8" y="2381"/>
              <a:ext cx="86" cy="297"/>
            </a:xfrm>
            <a:custGeom>
              <a:avLst/>
              <a:gdLst>
                <a:gd name="T0" fmla="*/ 0 w 86"/>
                <a:gd name="T1" fmla="*/ 0 h 297"/>
                <a:gd name="T2" fmla="*/ 59 w 86"/>
                <a:gd name="T3" fmla="*/ 0 h 297"/>
                <a:gd name="T4" fmla="*/ 59 w 86"/>
                <a:gd name="T5" fmla="*/ 297 h 297"/>
                <a:gd name="T6" fmla="*/ 86 w 86"/>
                <a:gd name="T7" fmla="*/ 297 h 2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86" h="297">
                  <a:moveTo>
                    <a:pt x="0" y="0"/>
                  </a:moveTo>
                  <a:lnTo>
                    <a:pt x="59" y="0"/>
                  </a:lnTo>
                  <a:lnTo>
                    <a:pt x="59" y="297"/>
                  </a:lnTo>
                  <a:lnTo>
                    <a:pt x="86" y="297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" name="Freeform 33">
              <a:extLst>
                <a:ext uri="{FF2B5EF4-FFF2-40B4-BE49-F238E27FC236}">
                  <a16:creationId xmlns:a16="http://schemas.microsoft.com/office/drawing/2014/main" id="{BEC39ABE-8EEF-442D-A96A-F41A837E34AA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0" y="2656"/>
              <a:ext cx="36" cy="43"/>
            </a:xfrm>
            <a:custGeom>
              <a:avLst/>
              <a:gdLst>
                <a:gd name="T0" fmla="*/ 0 w 36"/>
                <a:gd name="T1" fmla="*/ 0 h 43"/>
                <a:gd name="T2" fmla="*/ 36 w 36"/>
                <a:gd name="T3" fmla="*/ 22 h 43"/>
                <a:gd name="T4" fmla="*/ 0 w 36"/>
                <a:gd name="T5" fmla="*/ 43 h 43"/>
                <a:gd name="T6" fmla="*/ 0 w 36"/>
                <a:gd name="T7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43">
                  <a:moveTo>
                    <a:pt x="0" y="0"/>
                  </a:moveTo>
                  <a:lnTo>
                    <a:pt x="36" y="22"/>
                  </a:lnTo>
                  <a:lnTo>
                    <a:pt x="0" y="4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" name="Freeform 34">
              <a:extLst>
                <a:ext uri="{FF2B5EF4-FFF2-40B4-BE49-F238E27FC236}">
                  <a16:creationId xmlns:a16="http://schemas.microsoft.com/office/drawing/2014/main" id="{5D7FDA26-CEA9-456F-BAB5-7C4DB3B7F03E}"/>
                </a:ext>
              </a:extLst>
            </p:cNvPr>
            <p:cNvSpPr>
              <a:spLocks/>
            </p:cNvSpPr>
            <p:nvPr/>
          </p:nvSpPr>
          <p:spPr bwMode="auto">
            <a:xfrm>
              <a:off x="2274" y="1928"/>
              <a:ext cx="243" cy="750"/>
            </a:xfrm>
            <a:custGeom>
              <a:avLst/>
              <a:gdLst>
                <a:gd name="T0" fmla="*/ 0 w 243"/>
                <a:gd name="T1" fmla="*/ 750 h 750"/>
                <a:gd name="T2" fmla="*/ 142 w 243"/>
                <a:gd name="T3" fmla="*/ 750 h 750"/>
                <a:gd name="T4" fmla="*/ 142 w 243"/>
                <a:gd name="T5" fmla="*/ 0 h 750"/>
                <a:gd name="T6" fmla="*/ 243 w 243"/>
                <a:gd name="T7" fmla="*/ 0 h 7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43" h="750">
                  <a:moveTo>
                    <a:pt x="0" y="750"/>
                  </a:moveTo>
                  <a:lnTo>
                    <a:pt x="142" y="750"/>
                  </a:lnTo>
                  <a:lnTo>
                    <a:pt x="142" y="0"/>
                  </a:lnTo>
                  <a:lnTo>
                    <a:pt x="243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" name="Freeform 35">
              <a:extLst>
                <a:ext uri="{FF2B5EF4-FFF2-40B4-BE49-F238E27FC236}">
                  <a16:creationId xmlns:a16="http://schemas.microsoft.com/office/drawing/2014/main" id="{9F7417FE-F396-42A3-BA7B-DE2FBFFD5E1D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3" y="1907"/>
              <a:ext cx="36" cy="43"/>
            </a:xfrm>
            <a:custGeom>
              <a:avLst/>
              <a:gdLst>
                <a:gd name="T0" fmla="*/ 0 w 36"/>
                <a:gd name="T1" fmla="*/ 0 h 43"/>
                <a:gd name="T2" fmla="*/ 36 w 36"/>
                <a:gd name="T3" fmla="*/ 21 h 43"/>
                <a:gd name="T4" fmla="*/ 0 w 36"/>
                <a:gd name="T5" fmla="*/ 43 h 43"/>
                <a:gd name="T6" fmla="*/ 0 w 36"/>
                <a:gd name="T7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43">
                  <a:moveTo>
                    <a:pt x="0" y="0"/>
                  </a:moveTo>
                  <a:lnTo>
                    <a:pt x="36" y="21"/>
                  </a:lnTo>
                  <a:lnTo>
                    <a:pt x="0" y="4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" name="Freeform 36">
              <a:extLst>
                <a:ext uri="{FF2B5EF4-FFF2-40B4-BE49-F238E27FC236}">
                  <a16:creationId xmlns:a16="http://schemas.microsoft.com/office/drawing/2014/main" id="{FED4073C-B012-40D7-9076-67E1508A12C2}"/>
                </a:ext>
              </a:extLst>
            </p:cNvPr>
            <p:cNvSpPr>
              <a:spLocks/>
            </p:cNvSpPr>
            <p:nvPr/>
          </p:nvSpPr>
          <p:spPr bwMode="auto">
            <a:xfrm>
              <a:off x="2274" y="1928"/>
              <a:ext cx="243" cy="360"/>
            </a:xfrm>
            <a:custGeom>
              <a:avLst/>
              <a:gdLst>
                <a:gd name="T0" fmla="*/ 0 w 243"/>
                <a:gd name="T1" fmla="*/ 45 h 360"/>
                <a:gd name="T2" fmla="*/ 30 w 243"/>
                <a:gd name="T3" fmla="*/ 45 h 360"/>
                <a:gd name="T4" fmla="*/ 30 w 243"/>
                <a:gd name="T5" fmla="*/ 360 h 360"/>
                <a:gd name="T6" fmla="*/ 142 w 243"/>
                <a:gd name="T7" fmla="*/ 360 h 360"/>
                <a:gd name="T8" fmla="*/ 142 w 243"/>
                <a:gd name="T9" fmla="*/ 0 h 360"/>
                <a:gd name="T10" fmla="*/ 243 w 243"/>
                <a:gd name="T11" fmla="*/ 0 h 3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43" h="360">
                  <a:moveTo>
                    <a:pt x="0" y="45"/>
                  </a:moveTo>
                  <a:lnTo>
                    <a:pt x="30" y="45"/>
                  </a:lnTo>
                  <a:lnTo>
                    <a:pt x="30" y="360"/>
                  </a:lnTo>
                  <a:lnTo>
                    <a:pt x="142" y="360"/>
                  </a:lnTo>
                  <a:lnTo>
                    <a:pt x="142" y="0"/>
                  </a:lnTo>
                  <a:lnTo>
                    <a:pt x="243" y="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0" name="Freeform 37">
              <a:extLst>
                <a:ext uri="{FF2B5EF4-FFF2-40B4-BE49-F238E27FC236}">
                  <a16:creationId xmlns:a16="http://schemas.microsoft.com/office/drawing/2014/main" id="{CD7D094C-1EB3-4A1E-AC76-DF978A576F6F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3" y="1907"/>
              <a:ext cx="36" cy="43"/>
            </a:xfrm>
            <a:custGeom>
              <a:avLst/>
              <a:gdLst>
                <a:gd name="T0" fmla="*/ 0 w 36"/>
                <a:gd name="T1" fmla="*/ 0 h 43"/>
                <a:gd name="T2" fmla="*/ 36 w 36"/>
                <a:gd name="T3" fmla="*/ 21 h 43"/>
                <a:gd name="T4" fmla="*/ 0 w 36"/>
                <a:gd name="T5" fmla="*/ 43 h 43"/>
                <a:gd name="T6" fmla="*/ 0 w 36"/>
                <a:gd name="T7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43">
                  <a:moveTo>
                    <a:pt x="0" y="0"/>
                  </a:moveTo>
                  <a:lnTo>
                    <a:pt x="36" y="21"/>
                  </a:lnTo>
                  <a:lnTo>
                    <a:pt x="0" y="4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" name="Line 38">
              <a:extLst>
                <a:ext uri="{FF2B5EF4-FFF2-40B4-BE49-F238E27FC236}">
                  <a16:creationId xmlns:a16="http://schemas.microsoft.com/office/drawing/2014/main" id="{AC190A32-CB08-4A99-AEF5-B758B24B8E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3" y="2085"/>
              <a:ext cx="0" cy="4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2" name="Freeform 39">
              <a:extLst>
                <a:ext uri="{FF2B5EF4-FFF2-40B4-BE49-F238E27FC236}">
                  <a16:creationId xmlns:a16="http://schemas.microsoft.com/office/drawing/2014/main" id="{0AE14389-8A20-45AF-A7CF-BE47551FF99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5" y="2523"/>
              <a:ext cx="36" cy="43"/>
            </a:xfrm>
            <a:custGeom>
              <a:avLst/>
              <a:gdLst>
                <a:gd name="T0" fmla="*/ 36 w 36"/>
                <a:gd name="T1" fmla="*/ 0 h 43"/>
                <a:gd name="T2" fmla="*/ 18 w 36"/>
                <a:gd name="T3" fmla="*/ 43 h 43"/>
                <a:gd name="T4" fmla="*/ 0 w 36"/>
                <a:gd name="T5" fmla="*/ 0 h 43"/>
                <a:gd name="T6" fmla="*/ 36 w 36"/>
                <a:gd name="T7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43">
                  <a:moveTo>
                    <a:pt x="36" y="0"/>
                  </a:moveTo>
                  <a:lnTo>
                    <a:pt x="18" y="43"/>
                  </a:lnTo>
                  <a:lnTo>
                    <a:pt x="0" y="0"/>
                  </a:lnTo>
                  <a:lnTo>
                    <a:pt x="3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" name="Line 40">
              <a:extLst>
                <a:ext uri="{FF2B5EF4-FFF2-40B4-BE49-F238E27FC236}">
                  <a16:creationId xmlns:a16="http://schemas.microsoft.com/office/drawing/2014/main" id="{D85E39A8-EB7A-437F-844E-37A42D65288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77" y="2678"/>
              <a:ext cx="2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" name="Freeform 41">
              <a:extLst>
                <a:ext uri="{FF2B5EF4-FFF2-40B4-BE49-F238E27FC236}">
                  <a16:creationId xmlns:a16="http://schemas.microsoft.com/office/drawing/2014/main" id="{5B302D94-1118-438A-A120-781D1FFA471C}"/>
                </a:ext>
              </a:extLst>
            </p:cNvPr>
            <p:cNvSpPr>
              <a:spLocks/>
            </p:cNvSpPr>
            <p:nvPr/>
          </p:nvSpPr>
          <p:spPr bwMode="auto">
            <a:xfrm>
              <a:off x="3416" y="2656"/>
              <a:ext cx="36" cy="43"/>
            </a:xfrm>
            <a:custGeom>
              <a:avLst/>
              <a:gdLst>
                <a:gd name="T0" fmla="*/ 0 w 36"/>
                <a:gd name="T1" fmla="*/ 0 h 43"/>
                <a:gd name="T2" fmla="*/ 36 w 36"/>
                <a:gd name="T3" fmla="*/ 22 h 43"/>
                <a:gd name="T4" fmla="*/ 0 w 36"/>
                <a:gd name="T5" fmla="*/ 43 h 43"/>
                <a:gd name="T6" fmla="*/ 0 w 36"/>
                <a:gd name="T7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43">
                  <a:moveTo>
                    <a:pt x="0" y="0"/>
                  </a:moveTo>
                  <a:lnTo>
                    <a:pt x="36" y="22"/>
                  </a:lnTo>
                  <a:lnTo>
                    <a:pt x="0" y="4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" name="Line 42">
              <a:extLst>
                <a:ext uri="{FF2B5EF4-FFF2-40B4-BE49-F238E27FC236}">
                  <a16:creationId xmlns:a16="http://schemas.microsoft.com/office/drawing/2014/main" id="{189D77DA-6152-474A-B2E0-7456A8E9AB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66" y="2077"/>
              <a:ext cx="0" cy="48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" name="Freeform 43">
              <a:extLst>
                <a:ext uri="{FF2B5EF4-FFF2-40B4-BE49-F238E27FC236}">
                  <a16:creationId xmlns:a16="http://schemas.microsoft.com/office/drawing/2014/main" id="{05756EE4-7A3D-4BB1-ADEE-B00CC8BCFC71}"/>
                </a:ext>
              </a:extLst>
            </p:cNvPr>
            <p:cNvSpPr>
              <a:spLocks/>
            </p:cNvSpPr>
            <p:nvPr/>
          </p:nvSpPr>
          <p:spPr bwMode="auto">
            <a:xfrm>
              <a:off x="3748" y="2040"/>
              <a:ext cx="36" cy="43"/>
            </a:xfrm>
            <a:custGeom>
              <a:avLst/>
              <a:gdLst>
                <a:gd name="T0" fmla="*/ 0 w 36"/>
                <a:gd name="T1" fmla="*/ 43 h 43"/>
                <a:gd name="T2" fmla="*/ 18 w 36"/>
                <a:gd name="T3" fmla="*/ 0 h 43"/>
                <a:gd name="T4" fmla="*/ 36 w 36"/>
                <a:gd name="T5" fmla="*/ 43 h 43"/>
                <a:gd name="T6" fmla="*/ 0 w 36"/>
                <a:gd name="T7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43">
                  <a:moveTo>
                    <a:pt x="0" y="43"/>
                  </a:moveTo>
                  <a:lnTo>
                    <a:pt x="18" y="0"/>
                  </a:lnTo>
                  <a:lnTo>
                    <a:pt x="36" y="43"/>
                  </a:lnTo>
                  <a:lnTo>
                    <a:pt x="0" y="4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" name="Freeform 44">
              <a:extLst>
                <a:ext uri="{FF2B5EF4-FFF2-40B4-BE49-F238E27FC236}">
                  <a16:creationId xmlns:a16="http://schemas.microsoft.com/office/drawing/2014/main" id="{CCBF2D83-83CA-4E8B-A677-7AB5C76FAF4E}"/>
                </a:ext>
              </a:extLst>
            </p:cNvPr>
            <p:cNvSpPr>
              <a:spLocks/>
            </p:cNvSpPr>
            <p:nvPr/>
          </p:nvSpPr>
          <p:spPr bwMode="auto">
            <a:xfrm>
              <a:off x="4080" y="1928"/>
              <a:ext cx="316" cy="388"/>
            </a:xfrm>
            <a:custGeom>
              <a:avLst/>
              <a:gdLst>
                <a:gd name="T0" fmla="*/ 0 w 316"/>
                <a:gd name="T1" fmla="*/ 0 h 388"/>
                <a:gd name="T2" fmla="*/ 196 w 316"/>
                <a:gd name="T3" fmla="*/ 0 h 388"/>
                <a:gd name="T4" fmla="*/ 196 w 316"/>
                <a:gd name="T5" fmla="*/ 388 h 388"/>
                <a:gd name="T6" fmla="*/ 316 w 316"/>
                <a:gd name="T7" fmla="*/ 388 h 3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6" h="388">
                  <a:moveTo>
                    <a:pt x="0" y="0"/>
                  </a:moveTo>
                  <a:lnTo>
                    <a:pt x="196" y="0"/>
                  </a:lnTo>
                  <a:lnTo>
                    <a:pt x="196" y="388"/>
                  </a:lnTo>
                  <a:lnTo>
                    <a:pt x="316" y="38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" name="Freeform 45">
              <a:extLst>
                <a:ext uri="{FF2B5EF4-FFF2-40B4-BE49-F238E27FC236}">
                  <a16:creationId xmlns:a16="http://schemas.microsoft.com/office/drawing/2014/main" id="{BED6AD8E-9952-41D4-8337-5D013F60FCA4}"/>
                </a:ext>
              </a:extLst>
            </p:cNvPr>
            <p:cNvSpPr>
              <a:spLocks/>
            </p:cNvSpPr>
            <p:nvPr/>
          </p:nvSpPr>
          <p:spPr bwMode="auto">
            <a:xfrm>
              <a:off x="4392" y="2295"/>
              <a:ext cx="36" cy="43"/>
            </a:xfrm>
            <a:custGeom>
              <a:avLst/>
              <a:gdLst>
                <a:gd name="T0" fmla="*/ 0 w 36"/>
                <a:gd name="T1" fmla="*/ 0 h 43"/>
                <a:gd name="T2" fmla="*/ 36 w 36"/>
                <a:gd name="T3" fmla="*/ 21 h 43"/>
                <a:gd name="T4" fmla="*/ 0 w 36"/>
                <a:gd name="T5" fmla="*/ 43 h 43"/>
                <a:gd name="T6" fmla="*/ 0 w 36"/>
                <a:gd name="T7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6" h="43">
                  <a:moveTo>
                    <a:pt x="0" y="0"/>
                  </a:moveTo>
                  <a:lnTo>
                    <a:pt x="36" y="21"/>
                  </a:lnTo>
                  <a:lnTo>
                    <a:pt x="0" y="4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5647862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</Words>
  <Application>Microsoft Office PowerPoint</Application>
  <PresentationFormat>宽屏</PresentationFormat>
  <Paragraphs>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</dc:creator>
  <cp:lastModifiedBy>Think</cp:lastModifiedBy>
  <cp:revision>1</cp:revision>
  <dcterms:created xsi:type="dcterms:W3CDTF">2022-06-29T03:07:09Z</dcterms:created>
  <dcterms:modified xsi:type="dcterms:W3CDTF">2022-06-29T03:07:14Z</dcterms:modified>
</cp:coreProperties>
</file>